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ct" ContentType="image/x-pict"/>
  <Override PartName="/ppt/media/image3.pct" ContentType="image/x-pict"/>
  <Override PartName="/ppt/media/image4.pct" ContentType="image/x-pict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68DDB-0E93-418C-AA93-8B7F9B2E39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AFF6E-82B7-4056-905E-07F7A08DBD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C5BA9-E905-4839-94D5-24B0AA72DC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0BE99-E979-443D-981C-EC50236F9B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3163A-1292-4DA3-9B50-11ECFC6037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BB28F-52AF-4DE3-B5CD-1DE4D6C094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67296-DD91-4DF1-ACDD-E61B5D6903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C3B6A-C853-4BDC-9C94-2E94CE8DDD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68349-9042-498D-8AEC-672A8C5E8F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3153BA-1622-40B8-A4D1-94F5E3371E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4BA6E5-5C2F-4324-A8F2-781FC844F3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8B99B-C521-46DC-A42D-2D79092D86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C5C868-EBD2-4247-93AE-577D80C635F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ct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pct"/><Relationship Id="rId6" Type="http://schemas.openxmlformats.org/officeDocument/2006/relationships/oleObject" Target="../embeddings/oleObject3.bin"/><Relationship Id="rId7" Type="http://schemas.openxmlformats.org/officeDocument/2006/relationships/image" Target="../media/image4.pct"/><Relationship Id="rId8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 rot="5400000">
            <a:off x="1122840" y="19800"/>
            <a:ext cx="4535640" cy="586728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17680" y="5099040"/>
            <a:ext cx="6035400" cy="286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Figure S1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Magnitude of the oscillations in the output as a response to oscillations in the input about a background kinase level.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Plots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, B, C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show the output oscillations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O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of the hyperbolic, signal transducing, threshold-hyperbolic and ultrasensitive switches, respectively (normalized by the steady-state saturation value of each cycle), shown in Figure 2,  in response to an input of the form                          . The magnitude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O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is color coded and shown as a function of the input amplitude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frequency 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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. Output oscillations increase with increasing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and decrease with increasing 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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s expected. The four cycles, however, respond very differently to their inputs. The parameters used for the cycles are the same as those in Figure 2, and         nM except for the threshold-hyperbolic switch,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where              nM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3429000" y="6172200"/>
          <a:ext cx="1257480" cy="24120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3429000" y="6172200"/>
                    <a:ext cx="1257480" cy="241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5715000" y="7086600"/>
          <a:ext cx="520560" cy="24120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5715000" y="7086600"/>
                    <a:ext cx="520560" cy="241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1073160" y="7505640"/>
          <a:ext cx="584280" cy="24120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1073160" y="7505640"/>
                    <a:ext cx="584280" cy="241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23T02:48:51Z</dcterms:created>
  <dc:creator>Leonid Mirny</dc:creator>
  <dc:description/>
  <dc:language>en-US</dc:language>
  <cp:lastModifiedBy>Leonid Mirny</cp:lastModifiedBy>
  <dcterms:modified xsi:type="dcterms:W3CDTF">2007-10-23T03:00:32Z</dcterms:modified>
  <cp:revision>1</cp:revision>
  <dc:subject/>
  <dc:title>PowerPoint Presentation</dc:title>
</cp:coreProperties>
</file>